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53D2042-B077-45CE-A0AB-D072ECF2E8C0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6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スライド番号プレースホル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3B3180D-A86B-4A78-A2F9-83B2AC74C5C8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6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スライド番号プレースホル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D4CDEC4-E5A8-40CE-9EC6-E3FE8CB51037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6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スライド番号プレースホル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C65ACCF-B0AE-46CE-98A4-342FD99D964B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7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スライド番号プレースホル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23278FE-62BD-4731-BA0F-F6E136400D3C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0EEB0E-ED64-441A-BE10-D3DAB78C381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5AECFC-194E-4C5B-BF7A-8A68200A065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DC8C48-3E2E-4E34-A9FF-8976784EC35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BD5E96-44D6-4B12-9984-6108572FF39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E6D628-581C-4BD9-B8E1-9C2595A5016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F1DC59-D1D9-4821-86AF-E89E07314A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54D1A4-1DA0-4CD2-BDB0-C5AA6FF349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6C4D79-AE5A-4689-A083-279313D351F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562DC2-7C07-4C2B-BAB2-82702AF84C8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8F2D01-E433-4F28-8A6D-37842F1614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10F417-B13C-41EE-83FD-06478140AB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671366-54D2-4AAE-88A4-DC919AB975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6399C67-327B-4F92-9E1D-3DA4F19562DB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image" Target="../media/image4.jpe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4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テキスト ボックス 3"/>
          <p:cNvSpPr/>
          <p:nvPr/>
        </p:nvSpPr>
        <p:spPr>
          <a:xfrm>
            <a:off x="549360" y="399960"/>
            <a:ext cx="496728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Additional file 6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テキスト ボックス 4"/>
          <p:cNvSpPr/>
          <p:nvPr/>
        </p:nvSpPr>
        <p:spPr>
          <a:xfrm>
            <a:off x="552600" y="1052640"/>
            <a:ext cx="5684760" cy="648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Figure 1. Gene Ontology analysis of glomerulus proteome using Cellular Component and Molecular Function vocabulari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All the identified proteins of the non-redundant, high-confidence dataset of glomerulus proteome consisting of 1,817 unique proteins representing 1,478 unique genes were analyzed based onGene Ontology (GO) Cellular Component (</a:t>
            </a:r>
            <a:r>
              <a:rPr b="0" i="1" lang="en-GB" sz="1400" spc="-1" strike="noStrike">
                <a:solidFill>
                  <a:srgbClr val="000000"/>
                </a:solidFill>
                <a:latin typeface="Arial"/>
              </a:rPr>
              <a:t>Panel A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) and GO Molecular Function (</a:t>
            </a:r>
            <a:r>
              <a:rPr b="0" i="1" lang="en-GB" sz="1400" spc="-1" strike="noStrike">
                <a:solidFill>
                  <a:srgbClr val="000000"/>
                </a:solidFill>
                <a:latin typeface="Arial"/>
              </a:rPr>
              <a:t>Panel B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) vocabularies using PANTHER version 7 [7]. The number of hits to each of the GO terms are indicated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 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Figure 2. Gene Ontology analysis of glomerulus proteome using Biological Process vocabular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All the identified proteins of the non-redundant, high-confidence dataset of glomerulus proteome consisting of 1,817 unique proteins representing 1,478 unique genes were analyzed. In </a:t>
            </a:r>
            <a:r>
              <a:rPr b="0" i="1" lang="en-GB" sz="1400" spc="-1" strike="noStrike">
                <a:solidFill>
                  <a:srgbClr val="000000"/>
                </a:solidFill>
                <a:latin typeface="Arial"/>
              </a:rPr>
              <a:t>Panel A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, the proteins were analyzed on the basis of GO Biological Process vocabulary by using PANTHER version 7 [7]. The number of hits to each of GO terms is indicated. In </a:t>
            </a:r>
            <a:r>
              <a:rPr b="0" i="1" lang="en-GB" sz="1400" spc="-1" strike="noStrike">
                <a:solidFill>
                  <a:srgbClr val="000000"/>
                </a:solidFill>
                <a:latin typeface="Arial"/>
              </a:rPr>
              <a:t>Panel B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, enrichment analysis was performed on the basis of GO Biological Process vocabulary using Cytoscape version 2.82 coupled with BinGO plug-in [8] using the results of products of whole human genes as a background. Only terms with hits significantly higher than those of human genes are shown. Statistical significance was assessed as described in the text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 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Figure 3. PANTHER Protein Class analysis of glomerulus proteom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All the identified proteins of the non-redundant, high-confidence dataset of glomerulus proteome consisting of 1,817 unique proteins representing 1,478 unique genes were analyzed using PANTHER Protein Class analysis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図 1" descr="Panther_CC.jpg"/>
          <p:cNvPicPr/>
          <p:nvPr/>
        </p:nvPicPr>
        <p:blipFill>
          <a:blip r:embed="rId1"/>
          <a:stretch/>
        </p:blipFill>
        <p:spPr>
          <a:xfrm>
            <a:off x="563400" y="611280"/>
            <a:ext cx="5119920" cy="2555640"/>
          </a:xfrm>
          <a:prstGeom prst="rect">
            <a:avLst/>
          </a:prstGeom>
          <a:ln w="0">
            <a:noFill/>
          </a:ln>
        </p:spPr>
      </p:pic>
      <p:pic>
        <p:nvPicPr>
          <p:cNvPr id="51" name="図 3" descr="Panther_MF.jpg"/>
          <p:cNvPicPr/>
          <p:nvPr/>
        </p:nvPicPr>
        <p:blipFill>
          <a:blip r:embed="rId2"/>
          <a:stretch/>
        </p:blipFill>
        <p:spPr>
          <a:xfrm>
            <a:off x="655560" y="3225960"/>
            <a:ext cx="5853240" cy="5364000"/>
          </a:xfrm>
          <a:prstGeom prst="rect">
            <a:avLst/>
          </a:prstGeom>
          <a:ln w="0">
            <a:noFill/>
          </a:ln>
        </p:spPr>
      </p:pic>
      <p:sp>
        <p:nvSpPr>
          <p:cNvPr id="52" name="テキスト ボックス 6"/>
          <p:cNvSpPr/>
          <p:nvPr/>
        </p:nvSpPr>
        <p:spPr>
          <a:xfrm>
            <a:off x="4508640" y="8675640"/>
            <a:ext cx="216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Fig. 1 Cui et a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テキスト ボックス 8"/>
          <p:cNvSpPr/>
          <p:nvPr/>
        </p:nvSpPr>
        <p:spPr>
          <a:xfrm>
            <a:off x="476280" y="336600"/>
            <a:ext cx="2887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テキスト ボックス 9"/>
          <p:cNvSpPr/>
          <p:nvPr/>
        </p:nvSpPr>
        <p:spPr>
          <a:xfrm>
            <a:off x="476280" y="2897280"/>
            <a:ext cx="2887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図 1" descr="Panther_BP.jpg"/>
          <p:cNvPicPr/>
          <p:nvPr/>
        </p:nvPicPr>
        <p:blipFill>
          <a:blip r:embed="rId1"/>
          <a:stretch/>
        </p:blipFill>
        <p:spPr>
          <a:xfrm>
            <a:off x="549360" y="200160"/>
            <a:ext cx="5829120" cy="4851360"/>
          </a:xfrm>
          <a:prstGeom prst="rect">
            <a:avLst/>
          </a:prstGeom>
          <a:ln w="0">
            <a:noFill/>
          </a:ln>
        </p:spPr>
      </p:pic>
      <p:pic>
        <p:nvPicPr>
          <p:cNvPr id="56" name="図 2" descr="Cytoscape_BP.pdf.jpg"/>
          <p:cNvPicPr/>
          <p:nvPr/>
        </p:nvPicPr>
        <p:blipFill>
          <a:blip r:embed="rId2"/>
          <a:stretch/>
        </p:blipFill>
        <p:spPr>
          <a:xfrm>
            <a:off x="720720" y="5100480"/>
            <a:ext cx="5661000" cy="4008600"/>
          </a:xfrm>
          <a:prstGeom prst="rect">
            <a:avLst/>
          </a:prstGeom>
          <a:ln w="0">
            <a:noFill/>
          </a:ln>
        </p:spPr>
      </p:pic>
      <p:sp>
        <p:nvSpPr>
          <p:cNvPr id="57" name="テキスト ボックス 3"/>
          <p:cNvSpPr/>
          <p:nvPr/>
        </p:nvSpPr>
        <p:spPr>
          <a:xfrm>
            <a:off x="336600" y="77760"/>
            <a:ext cx="2887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テキスト ボックス 4"/>
          <p:cNvSpPr/>
          <p:nvPr/>
        </p:nvSpPr>
        <p:spPr>
          <a:xfrm>
            <a:off x="336600" y="4583160"/>
            <a:ext cx="2887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テキスト ボックス 5"/>
          <p:cNvSpPr/>
          <p:nvPr/>
        </p:nvSpPr>
        <p:spPr>
          <a:xfrm>
            <a:off x="41400" y="8782200"/>
            <a:ext cx="2016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Fig. 2 Cui et a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図 1" descr="Panther_PClass.jpg"/>
          <p:cNvPicPr/>
          <p:nvPr/>
        </p:nvPicPr>
        <p:blipFill>
          <a:blip r:embed="rId1"/>
          <a:stretch/>
        </p:blipFill>
        <p:spPr>
          <a:xfrm>
            <a:off x="0" y="1778040"/>
            <a:ext cx="6858000" cy="4800600"/>
          </a:xfrm>
          <a:prstGeom prst="rect">
            <a:avLst/>
          </a:prstGeom>
          <a:ln w="0">
            <a:noFill/>
          </a:ln>
        </p:spPr>
      </p:pic>
      <p:sp>
        <p:nvSpPr>
          <p:cNvPr id="61" name="テキスト ボックス 2"/>
          <p:cNvSpPr/>
          <p:nvPr/>
        </p:nvSpPr>
        <p:spPr>
          <a:xfrm>
            <a:off x="4894200" y="8794800"/>
            <a:ext cx="1924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Fig. 3 Cui et a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2-13T05:51:37Z</dcterms:created>
  <dc:creator>Yutaka Yoshida</dc:creator>
  <dc:description/>
  <dc:language>en-US</dc:language>
  <cp:lastModifiedBy>Yutaka Yoshida</cp:lastModifiedBy>
  <dcterms:modified xsi:type="dcterms:W3CDTF">2013-03-27T02:52:15Z</dcterms:modified>
  <cp:revision>3</cp:revision>
  <dc:subject/>
  <dc:title>スライド 1</dc:title>
</cp:coreProperties>
</file>